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6" r:id="rId2"/>
  </p:sldIdLst>
  <p:sldSz cx="6400800" cy="82296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00"/>
    <a:srgbClr val="8BD5B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42" autoAdjust="0"/>
    <p:restoredTop sz="94660"/>
  </p:normalViewPr>
  <p:slideViewPr>
    <p:cSldViewPr snapToGrid="0">
      <p:cViewPr varScale="1">
        <p:scale>
          <a:sx n="83" d="100"/>
          <a:sy n="83" d="100"/>
        </p:scale>
        <p:origin x="4180" y="7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23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7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524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9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3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87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6620" y="6135999"/>
            <a:ext cx="5486876" cy="156071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2717" y="4274630"/>
            <a:ext cx="5480779" cy="156071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1863" y="2382888"/>
            <a:ext cx="5462489" cy="156680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7959" y="412959"/>
            <a:ext cx="5456393" cy="1554615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8420" y="189952"/>
            <a:ext cx="82907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enario 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38420" y="2146899"/>
            <a:ext cx="82907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enario 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8420" y="4032762"/>
            <a:ext cx="82907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enario 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12220" y="517228"/>
            <a:ext cx="63030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</a:t>
            </a:r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370132" y="1377949"/>
            <a:ext cx="4748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SA</a:t>
            </a:r>
            <a:endParaRPr lang="en-US" sz="800" b="1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372594" y="1546536"/>
            <a:ext cx="47000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EG</a:t>
            </a:r>
            <a:endParaRPr lang="en-US" sz="800" b="1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45160" y="1709718"/>
            <a:ext cx="59343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rgbClr val="33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HMM</a:t>
            </a:r>
            <a:endParaRPr lang="en-US" sz="800" b="1" dirty="0">
              <a:solidFill>
                <a:srgbClr val="3333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212221" y="838885"/>
            <a:ext cx="63030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cap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238415" y="1079946"/>
            <a:ext cx="6046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0099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800" b="1" dirty="0">
              <a:solidFill>
                <a:srgbClr val="0099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211498" y="1224269"/>
            <a:ext cx="6383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8BD5B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800" b="1" dirty="0">
              <a:solidFill>
                <a:srgbClr val="8BD5B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185915" y="2477457"/>
            <a:ext cx="63030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</a:t>
            </a:r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343827" y="3332391"/>
            <a:ext cx="4748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SA</a:t>
            </a:r>
            <a:endParaRPr lang="en-US" sz="800" b="1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346289" y="3495191"/>
            <a:ext cx="47000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EG</a:t>
            </a:r>
            <a:endParaRPr lang="en-US" sz="800" b="1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218855" y="3645673"/>
            <a:ext cx="59343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rgbClr val="33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HMM</a:t>
            </a:r>
            <a:endParaRPr lang="en-US" sz="800" b="1" dirty="0">
              <a:solidFill>
                <a:srgbClr val="3333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185916" y="2792764"/>
            <a:ext cx="63030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cap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212110" y="3011240"/>
            <a:ext cx="6046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0099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800" b="1" dirty="0">
              <a:solidFill>
                <a:srgbClr val="0099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185193" y="3184498"/>
            <a:ext cx="6383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8BD5B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800" b="1" dirty="0">
              <a:solidFill>
                <a:srgbClr val="8BD5B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38419" y="5892793"/>
            <a:ext cx="82907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enario 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85915" y="4367836"/>
            <a:ext cx="63030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</a:t>
            </a:r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343827" y="5251705"/>
            <a:ext cx="4748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SA</a:t>
            </a:r>
            <a:endParaRPr lang="en-US" sz="800" b="1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346289" y="5408718"/>
            <a:ext cx="47000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EG</a:t>
            </a:r>
            <a:endParaRPr lang="en-US" sz="800" b="1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218855" y="5570774"/>
            <a:ext cx="59343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rgbClr val="33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HMM</a:t>
            </a:r>
            <a:endParaRPr lang="en-US" sz="800" b="1" dirty="0">
              <a:solidFill>
                <a:srgbClr val="3333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185916" y="4700504"/>
            <a:ext cx="63030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cap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212110" y="4918980"/>
            <a:ext cx="6046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0099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800" b="1" dirty="0">
              <a:solidFill>
                <a:srgbClr val="0099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85193" y="5092238"/>
            <a:ext cx="6383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8BD5B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800" b="1" dirty="0">
              <a:solidFill>
                <a:srgbClr val="8BD5B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188335" y="6226615"/>
            <a:ext cx="63030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</a:t>
            </a:r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346247" y="7122058"/>
            <a:ext cx="4748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SA</a:t>
            </a:r>
            <a:endParaRPr lang="en-US" sz="800" b="1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348709" y="7284858"/>
            <a:ext cx="47000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EG</a:t>
            </a:r>
            <a:endParaRPr lang="en-US" sz="800" b="1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221275" y="7452701"/>
            <a:ext cx="59343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err="1" smtClean="0">
                <a:solidFill>
                  <a:srgbClr val="33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HMM</a:t>
            </a:r>
            <a:endParaRPr lang="en-US" sz="800" b="1" dirty="0">
              <a:solidFill>
                <a:srgbClr val="3333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188336" y="6559283"/>
            <a:ext cx="63030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-cap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214530" y="6777759"/>
            <a:ext cx="6046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0099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800" b="1" dirty="0">
              <a:solidFill>
                <a:srgbClr val="0099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187613" y="6956804"/>
            <a:ext cx="6383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800" b="1" dirty="0" smtClean="0">
                <a:solidFill>
                  <a:srgbClr val="8BD5B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800" b="1" dirty="0">
              <a:solidFill>
                <a:srgbClr val="8BD5B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020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7</TotalTime>
  <Words>36</Words>
  <Application>Microsoft Office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ng</dc:creator>
  <cp:lastModifiedBy>Wang, Jing</cp:lastModifiedBy>
  <cp:revision>138</cp:revision>
  <cp:lastPrinted>2016-09-27T21:35:30Z</cp:lastPrinted>
  <dcterms:created xsi:type="dcterms:W3CDTF">2016-09-06T21:27:57Z</dcterms:created>
  <dcterms:modified xsi:type="dcterms:W3CDTF">2018-07-10T18:21:43Z</dcterms:modified>
</cp:coreProperties>
</file>